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1" autoAdjust="0"/>
    <p:restoredTop sz="94660"/>
  </p:normalViewPr>
  <p:slideViewPr>
    <p:cSldViewPr snapToGrid="0">
      <p:cViewPr varScale="1">
        <p:scale>
          <a:sx n="146" d="100"/>
          <a:sy n="146" d="100"/>
        </p:scale>
        <p:origin x="192" y="18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B46AB8-8CBA-41A4-93BC-6A3F577FC3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6A13375-F42A-4172-B594-01EA1E6D21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46896D6-3587-4EC1-9FB0-E09CDEC9B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4490A9F-7BBD-49D8-88FD-5BB417997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8C5580-9FF6-425F-A6C4-136006AC8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4450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A7AA94-21F8-4356-8FA0-8ADE6D430F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AB59298-6572-433B-9450-7A3D718585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D42CA3-5ACD-4C9D-A9A0-29B2ADB95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0756CB-F253-459A-908C-140EC6ADC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A1A404-2EC2-48D4-BA6D-68532780A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6039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26726EC-0A11-4BD3-A2F0-85F1D463D0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73485EF-EF7B-4703-B63E-691A4EA2B8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6FA2EF-FB50-4EB5-8EFD-2F438B582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C34192-61CD-4968-9C15-BBE981FF3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5200734-FBDE-40F0-905F-CB6D03BA5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3702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28A28F1-4D8C-47DF-91D3-C9FA6F7912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6C4C310-05FD-4294-A454-5B0DC7BDA9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805F353-2C9D-40BB-B2AB-05B457B96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6130A5-8A8F-4B84-83E8-08D0D83AD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0D3460-43A6-4E1E-9C07-7319153092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7891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7FCF62-F840-4699-AE7C-5D3864A30C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FCD4BD0-C0C8-4A66-AF2D-B811554A28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EFE80F-37D3-4F17-AD38-C6A7CF8E9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6280D9-B9A8-492B-8D0E-355E9636C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3A4866-7F48-4071-9A3D-9CAC163B2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660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A5ECEF-6294-40F0-975D-E0DFCD58E3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80AE6DA-8A52-4A78-BAEA-8C48423E29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E784D1B-1F7B-4ED4-96FC-FC92A34442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A357609-26E6-4A09-9927-D015FE997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75F60E0-2AC5-41EB-B434-205EE4780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99C5050-3433-4E95-ABED-4AC0B780E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6937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E5D33E-CD3B-4ED4-B24C-9D2BCA0BAA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E035EC0-87AC-4F90-87D0-B16888BA32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2943F4D-82F2-4B87-A824-F0BE95C13C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08C48AE2-109F-4D58-93D6-EE56E660F87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94CC01C-364A-45BD-9F41-18D868C269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81C33C1-4119-49ED-B08C-607445945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7EE6887-DCC2-49A0-9878-B08DFE0DC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6971EA3-F729-44CF-BCD1-56725A948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1120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911621E-559D-4434-B53E-D3B62BF70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E0B3120-7138-4BD2-9F4E-56BBF504E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239B4AB-92F1-4A95-80AD-F915D359D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9CAFFDC-8DBE-4A0E-8320-C9B90306E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3580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1F8B550-2719-410E-958E-C33F5E9C5B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C65CC69-7AE0-4A21-AA01-9A189B8F3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F991D2F-240E-4FA6-B64A-FEFA158F0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7989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740211-6279-476D-A2EB-840345F37F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FE5CFEF-E063-40CE-B9DB-A20BCDACF48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1F73BE5-58AA-4F61-9E7E-298874DED3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46B3DA4-6F72-4A3A-BE0A-6CECCFB0C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875E29-BA0E-4C1D-839D-22F200185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9B072D-FC1D-4D88-953E-4BB68B062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2900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2E948E2-9A3E-408A-B5BB-56722CA57B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C6FE894-CED8-4D6B-B3B4-F8AB8DF4DA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845741E-FA97-4F9F-9CB7-879B1F8BF0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A7CAB38-10A7-4381-9BEF-ADEF48EDB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467E1B-B713-4CE7-A608-149459742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21206D-8DFE-4E27-A906-1C6BD5933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9130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2AFCD4B-3266-475E-99DC-41B63E0245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857EA73-CABD-4D10-8F0C-B7164897D4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E2F493-514B-48B0-B86A-C3BB39A81A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EECBA-798E-4050-805D-BD15CC5DAFCD}" type="datetimeFigureOut">
              <a:rPr kumimoji="1" lang="ja-JP" altLang="en-US" smtClean="0"/>
              <a:t>2022/12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B1328D-C43A-4274-B5BE-07B4275415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E0591A7-E1C0-4E80-9B7A-A7940751CC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17ECF9-9E59-4586-A37D-6465FFBB07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7821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55565137-E2A5-478B-AD94-A33690423F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891" y="1206787"/>
            <a:ext cx="5875890" cy="3571970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796B64D-2928-4F8E-89DB-0CD1CF570D84}"/>
              </a:ext>
            </a:extLst>
          </p:cNvPr>
          <p:cNvSpPr txBox="1"/>
          <p:nvPr/>
        </p:nvSpPr>
        <p:spPr>
          <a:xfrm>
            <a:off x="444018" y="5162436"/>
            <a:ext cx="1133352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Figure S1</a:t>
            </a:r>
            <a:r>
              <a:rPr kumimoji="1"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. Beta diversity (</a:t>
            </a:r>
            <a:r>
              <a:rPr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weighted </a:t>
            </a:r>
            <a:r>
              <a:rPr lang="en-US" altLang="ja-JP" dirty="0" err="1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unifrac</a:t>
            </a:r>
            <a:r>
              <a:rPr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dirty="0" err="1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PCoA</a:t>
            </a:r>
            <a:r>
              <a:rPr kumimoji="1"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) comparisons between the data </a:t>
            </a:r>
            <a:r>
              <a:rPr kumimoji="1" lang="en-US" altLang="ja-JP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from control </a:t>
            </a:r>
            <a:r>
              <a:rPr kumimoji="1"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(C), </a:t>
            </a:r>
            <a:r>
              <a:rPr lang="en-US" altLang="ja-JP" i="1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W. coagulans </a:t>
            </a:r>
            <a:r>
              <a:rPr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strain SANK70258 (WC)-supplemented and </a:t>
            </a:r>
            <a:r>
              <a:rPr lang="en-US" altLang="ja-JP" dirty="0" err="1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lasalocid</a:t>
            </a:r>
            <a:r>
              <a:rPr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-A sodium (AM)-administered broilers</a:t>
            </a:r>
            <a:endParaRPr kumimoji="1" lang="en-US" altLang="ja-JP" dirty="0">
              <a:latin typeface="Times New Roman" panose="02020603050405020304" pitchFamily="18" charset="0"/>
              <a:ea typeface="Yu Gothic UI Semibold" panose="020B0700000000000000" pitchFamily="50" charset="-128"/>
              <a:cs typeface="Times New Roman" panose="02020603050405020304" pitchFamily="18" charset="0"/>
            </a:endParaRPr>
          </a:p>
          <a:p>
            <a:endParaRPr lang="en-US" altLang="ja-JP" dirty="0">
              <a:latin typeface="Times New Roman" panose="02020603050405020304" pitchFamily="18" charset="0"/>
              <a:ea typeface="Yu Gothic UI Semibold" panose="020B0700000000000000" pitchFamily="50" charset="-128"/>
              <a:cs typeface="Times New Roman" panose="02020603050405020304" pitchFamily="18" charset="0"/>
            </a:endParaRPr>
          </a:p>
          <a:p>
            <a:r>
              <a:rPr kumimoji="1"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A) Cecal digesta. B) Small intestinal digesta. Differences between groups were </a:t>
            </a:r>
            <a:r>
              <a:rPr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detecte</a:t>
            </a:r>
            <a:r>
              <a:rPr kumimoji="1" lang="en-US" altLang="ja-JP" dirty="0">
                <a:latin typeface="Times New Roman" panose="02020603050405020304" pitchFamily="18" charset="0"/>
                <a:ea typeface="Yu Gothic UI Semibold" panose="020B0700000000000000" pitchFamily="50" charset="-128"/>
                <a:cs typeface="Times New Roman" panose="02020603050405020304" pitchFamily="18" charset="0"/>
              </a:rPr>
              <a:t>d by a permutational analysis of variance (PERMANOVA). </a:t>
            </a:r>
            <a:endParaRPr kumimoji="1" lang="ja-JP" altLang="en-US" dirty="0">
              <a:latin typeface="Times New Roman" panose="02020603050405020304" pitchFamily="18" charset="0"/>
              <a:ea typeface="Yu Gothic UI Semibold" panose="020B0700000000000000" pitchFamily="50" charset="-128"/>
              <a:cs typeface="Times New Roman" panose="02020603050405020304" pitchFamily="18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3E928B0F-FA7C-4281-A662-6ECB688F5782}"/>
              </a:ext>
            </a:extLst>
          </p:cNvPr>
          <p:cNvSpPr/>
          <p:nvPr/>
        </p:nvSpPr>
        <p:spPr>
          <a:xfrm>
            <a:off x="5039522" y="1266735"/>
            <a:ext cx="1015068" cy="5704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ja-JP" altLang="en-US" sz="1050" dirty="0">
                <a:solidFill>
                  <a:srgbClr val="FF0000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●</a:t>
            </a:r>
            <a:r>
              <a:rPr lang="ja-JP" altLang="en-US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 </a:t>
            </a:r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Control (C)</a:t>
            </a:r>
          </a:p>
          <a:p>
            <a:pPr algn="ctr"/>
            <a:r>
              <a:rPr lang="ja-JP" altLang="en-US" sz="1050" dirty="0">
                <a:solidFill>
                  <a:srgbClr val="FFC000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●</a:t>
            </a:r>
            <a:r>
              <a:rPr lang="ja-JP" altLang="en-US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 </a:t>
            </a:r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WC (W)</a:t>
            </a:r>
          </a:p>
          <a:p>
            <a:pPr algn="ctr"/>
            <a:r>
              <a:rPr lang="ja-JP" altLang="en-US" sz="1050" dirty="0">
                <a:solidFill>
                  <a:srgbClr val="0070C0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●</a:t>
            </a:r>
            <a:r>
              <a:rPr lang="ja-JP" altLang="en-US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 </a:t>
            </a:r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AM (A)</a:t>
            </a:r>
          </a:p>
        </p:txBody>
      </p: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68993A4F-4D2D-43B7-8B6C-B4102D9E7FC1}"/>
              </a:ext>
            </a:extLst>
          </p:cNvPr>
          <p:cNvSpPr/>
          <p:nvPr/>
        </p:nvSpPr>
        <p:spPr>
          <a:xfrm>
            <a:off x="5038987" y="3554139"/>
            <a:ext cx="1015068" cy="7312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i="1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P</a:t>
            </a:r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 values</a:t>
            </a:r>
          </a:p>
          <a:p>
            <a:pPr algn="ctr"/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C vs. W: 0.100</a:t>
            </a:r>
          </a:p>
          <a:p>
            <a:pPr algn="ctr"/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C vs. A: 0.003</a:t>
            </a:r>
          </a:p>
          <a:p>
            <a:pPr algn="ctr"/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W vs. A: 0.126</a:t>
            </a: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B16129DA-CDCE-40AB-BFEF-0BD54F825CE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85147" y="1206787"/>
            <a:ext cx="5706387" cy="3571970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5E41C67-C412-4C50-8E0D-8014D84D60FD}"/>
              </a:ext>
            </a:extLst>
          </p:cNvPr>
          <p:cNvSpPr txBox="1"/>
          <p:nvPr/>
        </p:nvSpPr>
        <p:spPr>
          <a:xfrm>
            <a:off x="6540883" y="1513176"/>
            <a:ext cx="4010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solidFill>
                  <a:schemeClr val="bg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B)</a:t>
            </a:r>
            <a:endParaRPr lang="ja-JP" altLang="en-US" b="1" dirty="0">
              <a:solidFill>
                <a:schemeClr val="bg1"/>
              </a:solidFill>
              <a:latin typeface="Yu Gothic UI Semibold" panose="020B0700000000000000" pitchFamily="50" charset="-128"/>
              <a:ea typeface="Yu Gothic UI Semibold" panose="020B0700000000000000" pitchFamily="50" charset="-128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9CA9BA0-93EF-4815-A47F-9AE3DF42ECBE}"/>
              </a:ext>
            </a:extLst>
          </p:cNvPr>
          <p:cNvSpPr/>
          <p:nvPr/>
        </p:nvSpPr>
        <p:spPr>
          <a:xfrm>
            <a:off x="10907086" y="1266734"/>
            <a:ext cx="1015068" cy="5704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ja-JP" altLang="en-US" sz="1050" dirty="0">
                <a:solidFill>
                  <a:srgbClr val="FF0000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●</a:t>
            </a:r>
            <a:r>
              <a:rPr lang="ja-JP" altLang="en-US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 </a:t>
            </a:r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Control (C)</a:t>
            </a:r>
          </a:p>
          <a:p>
            <a:pPr algn="ctr"/>
            <a:r>
              <a:rPr lang="ja-JP" altLang="en-US" sz="1050" dirty="0">
                <a:solidFill>
                  <a:srgbClr val="FFC000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●</a:t>
            </a:r>
            <a:r>
              <a:rPr lang="ja-JP" altLang="en-US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 </a:t>
            </a:r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WC (W)</a:t>
            </a:r>
          </a:p>
          <a:p>
            <a:pPr algn="ctr"/>
            <a:r>
              <a:rPr lang="ja-JP" altLang="en-US" sz="1050" dirty="0">
                <a:solidFill>
                  <a:srgbClr val="0070C0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●</a:t>
            </a:r>
            <a:r>
              <a:rPr lang="ja-JP" altLang="en-US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 </a:t>
            </a:r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AM (A)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BC875556-4D71-41CC-A6C4-FB513C32F436}"/>
              </a:ext>
            </a:extLst>
          </p:cNvPr>
          <p:cNvSpPr/>
          <p:nvPr/>
        </p:nvSpPr>
        <p:spPr>
          <a:xfrm>
            <a:off x="10858151" y="3284174"/>
            <a:ext cx="1084448" cy="7312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i="1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P</a:t>
            </a:r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  values</a:t>
            </a:r>
          </a:p>
          <a:p>
            <a:pPr algn="ctr"/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C vs. W: 0.624</a:t>
            </a:r>
          </a:p>
          <a:p>
            <a:pPr algn="ctr"/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C vs. A: 0.169</a:t>
            </a:r>
          </a:p>
          <a:p>
            <a:pPr algn="ctr"/>
            <a:r>
              <a:rPr lang="en-US" altLang="ja-JP" sz="1050" dirty="0">
                <a:solidFill>
                  <a:schemeClr val="tx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W vs. A: 0.137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367B388-E0DC-4854-A59F-FC69999591CE}"/>
              </a:ext>
            </a:extLst>
          </p:cNvPr>
          <p:cNvSpPr txBox="1"/>
          <p:nvPr/>
        </p:nvSpPr>
        <p:spPr>
          <a:xfrm>
            <a:off x="346836" y="1569376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solidFill>
                  <a:schemeClr val="bg1"/>
                </a:solidFill>
                <a:latin typeface="Yu Gothic UI Semibold" panose="020B0700000000000000" pitchFamily="50" charset="-128"/>
                <a:ea typeface="Yu Gothic UI Semibold" panose="020B0700000000000000" pitchFamily="50" charset="-128"/>
              </a:rPr>
              <a:t>A)</a:t>
            </a:r>
            <a:endParaRPr lang="ja-JP" altLang="en-US" b="1" dirty="0">
              <a:solidFill>
                <a:schemeClr val="bg1"/>
              </a:solidFill>
              <a:latin typeface="Yu Gothic UI Semibold" panose="020B0700000000000000" pitchFamily="50" charset="-128"/>
              <a:ea typeface="Yu Gothic UI Semibold" panose="020B0700000000000000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131911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8</TotalTime>
  <Words>135</Words>
  <Application>Microsoft Macintosh PowerPoint</Application>
  <PresentationFormat>ワイド画面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Yu Gothic UI Semibold</vt:lpstr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ida masanori/0491767/相田　正典</dc:creator>
  <cp:lastModifiedBy>Tsukahara Takamitsu</cp:lastModifiedBy>
  <cp:revision>14</cp:revision>
  <dcterms:created xsi:type="dcterms:W3CDTF">2022-12-19T00:44:46Z</dcterms:created>
  <dcterms:modified xsi:type="dcterms:W3CDTF">2022-12-22T01:51:54Z</dcterms:modified>
</cp:coreProperties>
</file>